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BD194-B5E0-424E-8B83-5DCFC39D57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2A6A6-51F6-436C-BE44-E3F0FF889C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F4FEB-34EF-44AF-A2A2-A6273A41AE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5F0D2-102D-4F41-9EED-D071D3AF89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33DAA-010F-4225-9312-804DEA551D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7CF7E-8892-4BE2-BA33-4B2B9E7C3A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453A2-EACE-46E0-80A1-5247C168B6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1714B-2BE6-4D7B-BC19-188036661B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3F14B-EF15-4CBB-BE33-6145A25B2F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A91C2-E1B4-4842-A50C-CD464753A6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667DC-AF01-4FAF-AC9C-605BD47B8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6447D-4DE0-4499-9DC3-B0169E0421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95B07D-B484-4F26-A55A-E9A2BD60C67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0"/>
          <p:cNvSpPr/>
          <p:nvPr/>
        </p:nvSpPr>
        <p:spPr>
          <a:xfrm rot="16200000">
            <a:off x="105480" y="3052800"/>
            <a:ext cx="123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mRNA leve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2"/>
          <p:cNvGrpSpPr/>
          <p:nvPr/>
        </p:nvGrpSpPr>
        <p:grpSpPr>
          <a:xfrm>
            <a:off x="3490920" y="2232000"/>
            <a:ext cx="2295360" cy="1979640"/>
            <a:chOff x="3490920" y="2232000"/>
            <a:chExt cx="2295360" cy="1979640"/>
          </a:xfrm>
        </p:grpSpPr>
        <p:pic>
          <p:nvPicPr>
            <p:cNvPr id="43" name="Picture 6" descr=""/>
            <p:cNvPicPr/>
            <p:nvPr/>
          </p:nvPicPr>
          <p:blipFill>
            <a:blip r:embed="rId1"/>
            <a:stretch/>
          </p:blipFill>
          <p:spPr>
            <a:xfrm>
              <a:off x="3490920" y="2232000"/>
              <a:ext cx="2295360" cy="19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74"/>
            <p:cNvSpPr/>
            <p:nvPr/>
          </p:nvSpPr>
          <p:spPr>
            <a:xfrm>
              <a:off x="3844800" y="260892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QC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5" name="TextBox 78"/>
          <p:cNvSpPr/>
          <p:nvPr/>
        </p:nvSpPr>
        <p:spPr>
          <a:xfrm rot="16200000">
            <a:off x="2880360" y="3097080"/>
            <a:ext cx="123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mRNA leve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 43"/>
          <p:cNvGrpSpPr/>
          <p:nvPr/>
        </p:nvGrpSpPr>
        <p:grpSpPr>
          <a:xfrm>
            <a:off x="6227640" y="2241720"/>
            <a:ext cx="2295720" cy="1979280"/>
            <a:chOff x="6227640" y="2241720"/>
            <a:chExt cx="2295720" cy="1979280"/>
          </a:xfrm>
        </p:grpSpPr>
        <p:pic>
          <p:nvPicPr>
            <p:cNvPr id="47" name="Picture 7" descr=""/>
            <p:cNvPicPr/>
            <p:nvPr/>
          </p:nvPicPr>
          <p:blipFill>
            <a:blip r:embed="rId2"/>
            <a:stretch/>
          </p:blipFill>
          <p:spPr>
            <a:xfrm>
              <a:off x="6227640" y="2241720"/>
              <a:ext cx="2295720" cy="19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108"/>
            <p:cNvSpPr/>
            <p:nvPr/>
          </p:nvSpPr>
          <p:spPr>
            <a:xfrm>
              <a:off x="6581880" y="260784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DUFS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9" name="TextBox 109"/>
          <p:cNvSpPr/>
          <p:nvPr/>
        </p:nvSpPr>
        <p:spPr>
          <a:xfrm>
            <a:off x="389160" y="2241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0"/>
          <p:cNvSpPr/>
          <p:nvPr/>
        </p:nvSpPr>
        <p:spPr>
          <a:xfrm>
            <a:off x="3211200" y="22320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1"/>
          <p:cNvSpPr/>
          <p:nvPr/>
        </p:nvSpPr>
        <p:spPr>
          <a:xfrm>
            <a:off x="5947920" y="23130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70"/>
          <p:cNvSpPr/>
          <p:nvPr/>
        </p:nvSpPr>
        <p:spPr>
          <a:xfrm>
            <a:off x="1060560" y="4325760"/>
            <a:ext cx="7345080" cy="80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elative mRNA levels of selected genes in mitochondrial respiratory chain pathway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levels were analyzed in insulin-resistant (black bar) and insulin-sensitive subjects (white bar) at 0 h, 3 h, and 6 h during euglycaemic hyperinsulinaemia. All genes are differentially expressed between insulin-resistant and insulin-sensitive groups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roup) &lt; 0.05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roup*insulin) = NS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insulin) = NS for all genes via 2-way ANOVA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1"/>
          <p:cNvSpPr/>
          <p:nvPr/>
        </p:nvSpPr>
        <p:spPr>
          <a:xfrm>
            <a:off x="3721680" y="1125360"/>
            <a:ext cx="1688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6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" name="Group 41"/>
          <p:cNvGrpSpPr/>
          <p:nvPr/>
        </p:nvGrpSpPr>
        <p:grpSpPr>
          <a:xfrm>
            <a:off x="819000" y="2241720"/>
            <a:ext cx="2276640" cy="1962000"/>
            <a:chOff x="819000" y="2241720"/>
            <a:chExt cx="2276640" cy="1962000"/>
          </a:xfrm>
        </p:grpSpPr>
        <p:pic>
          <p:nvPicPr>
            <p:cNvPr id="55" name="Picture 5" descr=""/>
            <p:cNvPicPr/>
            <p:nvPr/>
          </p:nvPicPr>
          <p:blipFill>
            <a:blip r:embed="rId3"/>
            <a:stretch/>
          </p:blipFill>
          <p:spPr>
            <a:xfrm>
              <a:off x="819000" y="2241720"/>
              <a:ext cx="2276640" cy="196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34"/>
            <p:cNvSpPr/>
            <p:nvPr/>
          </p:nvSpPr>
          <p:spPr>
            <a:xfrm>
              <a:off x="1148040" y="2601720"/>
              <a:ext cx="65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X4L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106"/>
          <p:cNvSpPr/>
          <p:nvPr/>
        </p:nvSpPr>
        <p:spPr>
          <a:xfrm rot="16200000">
            <a:off x="5579280" y="3129480"/>
            <a:ext cx="123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mRNA leve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7T09:54:27Z</dcterms:created>
  <dc:creator>Jarkko</dc:creator>
  <dc:description/>
  <dc:language>en-US</dc:language>
  <cp:lastModifiedBy>Jarkko</cp:lastModifiedBy>
  <dcterms:modified xsi:type="dcterms:W3CDTF">2012-02-16T14:52:16Z</dcterms:modified>
  <cp:revision>47</cp:revision>
  <dc:subject/>
  <dc:title>Slide 1</dc:title>
</cp:coreProperties>
</file>